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2390" y="-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B46E0-57B2-406E-A580-FA0C16CE80D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126BD-FD33-4F7E-B864-87C79962861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6" name="Object 2"/>
          <p:cNvGraphicFramePr>
            <a:graphicFrameLocks noChangeAspect="1"/>
          </p:cNvGraphicFramePr>
          <p:nvPr/>
        </p:nvGraphicFramePr>
        <p:xfrm>
          <a:off x="2071678" y="357158"/>
          <a:ext cx="2651125" cy="2079625"/>
        </p:xfrm>
        <a:graphic>
          <a:graphicData uri="http://schemas.openxmlformats.org/presentationml/2006/ole">
            <p:oleObj spid="_x0000_s1026" name="Prism Project" r:id="rId3" imgW="3168000" imgH="2484000" progId="Prism5.Document">
              <p:embed/>
            </p:oleObj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1785926" y="2643174"/>
            <a:ext cx="40005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</a:t>
            </a:r>
            <a:r>
              <a:rPr lang="en-US" sz="1200" dirty="0" smtClean="0"/>
              <a:t>S6. Differential mRNA expression of </a:t>
            </a:r>
            <a:r>
              <a:rPr lang="en-US" sz="1200" i="1" dirty="0" smtClean="0"/>
              <a:t>FOXJ1</a:t>
            </a:r>
            <a:r>
              <a:rPr lang="en-US" sz="1200" dirty="0" smtClean="0"/>
              <a:t> in the PBECs from COPD patients and control subjects. PBECs from control 7-17 and COPD 6-16 (Table 1) were differentiated at ALI for 14 days. Expressions of </a:t>
            </a:r>
            <a:r>
              <a:rPr lang="en-US" sz="1200" i="1" dirty="0" smtClean="0"/>
              <a:t>FOXJ1</a:t>
            </a:r>
            <a:r>
              <a:rPr lang="en-US" sz="1200" dirty="0" smtClean="0"/>
              <a:t> were analyzed by real-time quantitative PCR. Significance was tested by the Mann-Whitney U test. Medians are indicated. ns = not significant.</a:t>
            </a:r>
            <a:endParaRPr lang="nl-NL" sz="1200" dirty="0" smtClean="0"/>
          </a:p>
          <a:p>
            <a:endParaRPr lang="nl-NL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5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2</cp:revision>
  <dcterms:created xsi:type="dcterms:W3CDTF">2016-12-16T16:51:35Z</dcterms:created>
  <dcterms:modified xsi:type="dcterms:W3CDTF">2016-12-16T17:39:26Z</dcterms:modified>
</cp:coreProperties>
</file>